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5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90"/>
    <p:restoredTop sz="94567" autoAdjust="0"/>
  </p:normalViewPr>
  <p:slideViewPr>
    <p:cSldViewPr snapToGrid="0" snapToObjects="1">
      <p:cViewPr>
        <p:scale>
          <a:sx n="150" d="100"/>
          <a:sy n="150" d="100"/>
        </p:scale>
        <p:origin x="760" y="144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11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図 129"/>
          <p:cNvPicPr>
            <a:picLocks noChangeAspect="1"/>
          </p:cNvPicPr>
          <p:nvPr/>
        </p:nvPicPr>
        <p:blipFill rotWithShape="1">
          <a:blip r:embed="rId2"/>
          <a:srcRect l="7798" r="8727" b="6714"/>
          <a:stretch/>
        </p:blipFill>
        <p:spPr>
          <a:xfrm>
            <a:off x="2887777" y="888463"/>
            <a:ext cx="1507083" cy="1103882"/>
          </a:xfrm>
          <a:prstGeom prst="rect">
            <a:avLst/>
          </a:prstGeom>
        </p:spPr>
      </p:pic>
      <p:pic>
        <p:nvPicPr>
          <p:cNvPr id="133" name="図 132"/>
          <p:cNvPicPr>
            <a:picLocks noChangeAspect="1"/>
          </p:cNvPicPr>
          <p:nvPr/>
        </p:nvPicPr>
        <p:blipFill rotWithShape="1">
          <a:blip r:embed="rId3"/>
          <a:srcRect l="14344" r="8299" b="7445"/>
          <a:stretch/>
        </p:blipFill>
        <p:spPr>
          <a:xfrm>
            <a:off x="5211454" y="862491"/>
            <a:ext cx="1533581" cy="1114920"/>
          </a:xfrm>
          <a:prstGeom prst="rect">
            <a:avLst/>
          </a:prstGeom>
        </p:spPr>
      </p:pic>
      <p:pic>
        <p:nvPicPr>
          <p:cNvPr id="137" name="図 136"/>
          <p:cNvPicPr>
            <a:picLocks noChangeAspect="1"/>
          </p:cNvPicPr>
          <p:nvPr/>
        </p:nvPicPr>
        <p:blipFill rotWithShape="1">
          <a:blip r:embed="rId4"/>
          <a:srcRect l="8199" r="26155" b="7240"/>
          <a:stretch/>
        </p:blipFill>
        <p:spPr>
          <a:xfrm>
            <a:off x="5202763" y="2430450"/>
            <a:ext cx="1510838" cy="1089221"/>
          </a:xfrm>
          <a:prstGeom prst="rect">
            <a:avLst/>
          </a:prstGeom>
        </p:spPr>
      </p:pic>
      <p:pic>
        <p:nvPicPr>
          <p:cNvPr id="138" name="図 137"/>
          <p:cNvPicPr>
            <a:picLocks noChangeAspect="1"/>
          </p:cNvPicPr>
          <p:nvPr/>
        </p:nvPicPr>
        <p:blipFill rotWithShape="1">
          <a:blip r:embed="rId5"/>
          <a:srcRect l="11986" r="8132" b="7049"/>
          <a:stretch/>
        </p:blipFill>
        <p:spPr>
          <a:xfrm>
            <a:off x="2893972" y="2430450"/>
            <a:ext cx="1506652" cy="109183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6"/>
          <a:srcRect l="14060" r="8808" b="6872"/>
          <a:stretch/>
        </p:blipFill>
        <p:spPr>
          <a:xfrm>
            <a:off x="612056" y="2436672"/>
            <a:ext cx="1488413" cy="1091974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7"/>
          <a:srcRect l="12242" r="8083" b="7488"/>
          <a:stretch/>
        </p:blipFill>
        <p:spPr>
          <a:xfrm>
            <a:off x="595442" y="881101"/>
            <a:ext cx="1516115" cy="1096310"/>
          </a:xfrm>
          <a:prstGeom prst="rect">
            <a:avLst/>
          </a:prstGeom>
        </p:spPr>
      </p:pic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153443" y="49035"/>
            <a:ext cx="584287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 dirty="0">
                <a:latin typeface="Helvetica"/>
                <a:cs typeface="Helvetica"/>
              </a:rPr>
              <a:t>Supplementary </a:t>
            </a:r>
            <a:r>
              <a:rPr lang="en-US" altLang="ja-JP" dirty="0" smtClean="0">
                <a:latin typeface="Helvetica"/>
                <a:cs typeface="Helvetica"/>
              </a:rPr>
              <a:t>Fig.S11_Kamiyama </a:t>
            </a:r>
            <a:r>
              <a:rPr lang="en-US" altLang="ja-JP" dirty="0">
                <a:latin typeface="Helvetica"/>
                <a:cs typeface="Helvetica"/>
              </a:rPr>
              <a:t>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1389835" y="1916717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736035" y="1909524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083891" y="599848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L2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375276" y="607568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 rot="16200000">
            <a:off x="-49129" y="1016554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4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2687977" y="1787869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687449" y="145991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5741540" y="614508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1119028" y="2137418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CL7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398661" y="2137418"/>
            <a:ext cx="5865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2649412" y="3317719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648884" y="3002127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2649412" y="2675971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2649412" y="2361355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5633065" y="2137418"/>
            <a:ext cx="6721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CCL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974459" y="3335713"/>
            <a:ext cx="262627" cy="2417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4967790" y="269451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63902" y="237045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74712" y="3001943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 rot="16200000">
            <a:off x="2292196" y="1010751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1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975631" y="1763887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 rot="16200000">
            <a:off x="4582711" y="981660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5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08223" y="139704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 rot="16200000">
            <a:off x="2236362" y="2495343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4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 rot="16200000">
            <a:off x="1534663" y="2483712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 rot="16200000">
            <a:off x="4609110" y="2528033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3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3896419" y="2463896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3708241" y="3457782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3036445" y="345677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xmlns="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3342367" y="2624016"/>
            <a:ext cx="6049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xmlns="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1054276" y="1047909"/>
            <a:ext cx="6049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1419264" y="3466326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765464" y="3459133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7" name="テキスト ボックス 86"/>
          <p:cNvSpPr txBox="1"/>
          <p:nvPr/>
        </p:nvSpPr>
        <p:spPr>
          <a:xfrm rot="16200000">
            <a:off x="-15200" y="2582346"/>
            <a:ext cx="635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(x10</a:t>
            </a:r>
            <a:r>
              <a:rPr lang="en-US" altLang="ja-JP" sz="1200" b="1" baseline="30000" dirty="0">
                <a:latin typeface="Helvetica"/>
                <a:cs typeface="Helvetica"/>
              </a:rPr>
              <a:t>-5</a:t>
            </a:r>
            <a:r>
              <a:rPr lang="en-US" altLang="ja-JP" sz="1200" b="1" dirty="0">
                <a:latin typeface="Helvetica"/>
                <a:cs typeface="Helvetica"/>
              </a:rPr>
              <a:t>)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93" name="直線コネクタ 92">
            <a:extLst>
              <a:ext uri="{FF2B5EF4-FFF2-40B4-BE49-F238E27FC236}">
                <a16:creationId xmlns:a16="http://schemas.microsoft.com/office/drawing/2014/main" xmlns="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1065120" y="2554153"/>
            <a:ext cx="6049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テキスト ボックス 93"/>
          <p:cNvSpPr txBox="1"/>
          <p:nvPr/>
        </p:nvSpPr>
        <p:spPr>
          <a:xfrm rot="16200000">
            <a:off x="-724862" y="2521022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01" name="直線コネクタ 100">
            <a:extLst>
              <a:ext uri="{FF2B5EF4-FFF2-40B4-BE49-F238E27FC236}">
                <a16:creationId xmlns:a16="http://schemas.microsoft.com/office/drawing/2014/main" xmlns="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3356243" y="1125454"/>
            <a:ext cx="6049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10218" y="1188184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972648" y="16014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06" name="直線コネクタ 105">
            <a:extLst>
              <a:ext uri="{FF2B5EF4-FFF2-40B4-BE49-F238E27FC236}">
                <a16:creationId xmlns:a16="http://schemas.microsoft.com/office/drawing/2014/main" xmlns="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5692675" y="967072"/>
            <a:ext cx="6049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7" name="直線コネクタ 106">
            <a:extLst>
              <a:ext uri="{FF2B5EF4-FFF2-40B4-BE49-F238E27FC236}">
                <a16:creationId xmlns:a16="http://schemas.microsoft.com/office/drawing/2014/main" xmlns="" id="{6DC12DAF-D84D-A149-BACF-21771DAE9F2A}"/>
              </a:ext>
            </a:extLst>
          </p:cNvPr>
          <p:cNvCxnSpPr>
            <a:cxnSpLocks/>
          </p:cNvCxnSpPr>
          <p:nvPr/>
        </p:nvCxnSpPr>
        <p:spPr>
          <a:xfrm>
            <a:off x="5667895" y="2483909"/>
            <a:ext cx="604904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6037010" y="347855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383210" y="347136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3711627" y="193056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3057827" y="1923371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6016947" y="1912493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DENV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xmlns="" id="{DE107980-2943-BD4E-936A-8EB9F837DD56}"/>
              </a:ext>
            </a:extLst>
          </p:cNvPr>
          <p:cNvSpPr txBox="1"/>
          <p:nvPr/>
        </p:nvSpPr>
        <p:spPr>
          <a:xfrm>
            <a:off x="5363147" y="1905300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CTRL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72984" y="1801835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xmlns="" id="{552FD492-0E6C-2447-9746-C05FAA652532}"/>
              </a:ext>
            </a:extLst>
          </p:cNvPr>
          <p:cNvSpPr txBox="1"/>
          <p:nvPr/>
        </p:nvSpPr>
        <p:spPr>
          <a:xfrm>
            <a:off x="366044" y="1600716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366044" y="1401046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366206" y="120286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366585" y="101809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305576" y="82374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1017973" y="848315"/>
            <a:ext cx="6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/>
                <a:cs typeface="Helvetica"/>
              </a:rPr>
              <a:t>N.S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21" name="テキスト ボックス 120"/>
          <p:cNvSpPr txBox="1"/>
          <p:nvPr/>
        </p:nvSpPr>
        <p:spPr>
          <a:xfrm rot="16200000">
            <a:off x="-758359" y="958065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406534" y="3326878"/>
            <a:ext cx="262627" cy="2417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339126" y="268746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341121" y="2373280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xmlns="" id="{F07E629E-B719-D946-9289-C4F6303E9A11}"/>
              </a:ext>
            </a:extLst>
          </p:cNvPr>
          <p:cNvSpPr txBox="1"/>
          <p:nvPr/>
        </p:nvSpPr>
        <p:spPr>
          <a:xfrm>
            <a:off x="397356" y="3009590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1057078" y="2334317"/>
            <a:ext cx="6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/>
                <a:cs typeface="Helvetica"/>
              </a:rPr>
              <a:t>N.S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3321100" y="2407867"/>
            <a:ext cx="6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/>
                <a:cs typeface="Helvetica"/>
              </a:rPr>
              <a:t>N.S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686054" y="1140532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9" name="テキスト ボックス 128">
            <a:extLst>
              <a:ext uri="{FF2B5EF4-FFF2-40B4-BE49-F238E27FC236}">
                <a16:creationId xmlns:a16="http://schemas.microsoft.com/office/drawing/2014/main" xmlns="" id="{51F2C97F-A165-5244-8373-37C7A6A7E526}"/>
              </a:ext>
            </a:extLst>
          </p:cNvPr>
          <p:cNvSpPr txBox="1"/>
          <p:nvPr/>
        </p:nvSpPr>
        <p:spPr>
          <a:xfrm>
            <a:off x="2680353" y="8175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1" name="テキスト ボックス 130"/>
          <p:cNvSpPr txBox="1"/>
          <p:nvPr/>
        </p:nvSpPr>
        <p:spPr>
          <a:xfrm rot="16200000">
            <a:off x="1588215" y="942673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14585" y="98222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xmlns="" id="{4A6B2414-AE33-0B4D-A30D-13F9DAF35054}"/>
              </a:ext>
            </a:extLst>
          </p:cNvPr>
          <p:cNvSpPr txBox="1"/>
          <p:nvPr/>
        </p:nvSpPr>
        <p:spPr>
          <a:xfrm>
            <a:off x="4916580" y="773362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 rot="16200000">
            <a:off x="3874648" y="930889"/>
            <a:ext cx="1880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 relative expression</a:t>
            </a:r>
          </a:p>
          <a:p>
            <a:r>
              <a:rPr lang="en-US" altLang="ja-JP" sz="1200" b="1" dirty="0">
                <a:latin typeface="Helvetica"/>
                <a:cs typeface="Helvetica"/>
              </a:rPr>
              <a:t> / β actin              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3338106" y="921055"/>
            <a:ext cx="6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/>
                <a:cs typeface="Helvetica"/>
              </a:rPr>
              <a:t>N.S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5657532" y="770713"/>
            <a:ext cx="6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/>
                <a:cs typeface="Helvetica"/>
              </a:rPr>
              <a:t>N.S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xmlns="" id="{881C648C-4D20-384D-AC37-A3723D2ABD15}"/>
              </a:ext>
            </a:extLst>
          </p:cNvPr>
          <p:cNvSpPr txBox="1"/>
          <p:nvPr/>
        </p:nvSpPr>
        <p:spPr>
          <a:xfrm>
            <a:off x="5631514" y="2285111"/>
            <a:ext cx="6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>
                <a:latin typeface="Helvetica"/>
                <a:cs typeface="Helvetica"/>
              </a:rPr>
              <a:t>N.S</a:t>
            </a:r>
            <a:endParaRPr lang="ja-JP" altLang="en-US" sz="1000" b="1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18990261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78</TotalTime>
  <Words>118</Words>
  <Application>Microsoft Macintosh PowerPoint</Application>
  <PresentationFormat>画面に合わせる (4:3)</PresentationFormat>
  <Paragraphs>7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ＭＳ Ｐゴシック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29</cp:revision>
  <cp:lastPrinted>2024-05-22T05:30:17Z</cp:lastPrinted>
  <dcterms:created xsi:type="dcterms:W3CDTF">2022-03-10T04:52:23Z</dcterms:created>
  <dcterms:modified xsi:type="dcterms:W3CDTF">2025-11-05T08:07:02Z</dcterms:modified>
  <cp:category/>
</cp:coreProperties>
</file>